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48"/>
  </p:normalViewPr>
  <p:slideViewPr>
    <p:cSldViewPr snapToGrid="0" snapToObjects="1">
      <p:cViewPr varScale="1">
        <p:scale>
          <a:sx n="117" d="100"/>
          <a:sy n="117" d="100"/>
        </p:scale>
        <p:origin x="360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007C14-16BB-00D4-DC12-87E8D0BDF4C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0B03F63-E2B4-DF90-028F-5C0FB90F79F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9812F0-5CB4-30E2-09DC-B7BF99254D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A0CD62-EA7A-3449-9538-B12C3AD6BBA4}" type="datetimeFigureOut">
              <a:rPr lang="en-US" smtClean="0"/>
              <a:t>6/2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EB5F15B-3C31-C25D-AC69-6D22DF1FC9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2C82121-5BA4-3D96-26E7-AF0B533512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F17836-3677-1E47-98B4-AD2054ABDD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68364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FB2AE7-AF85-5821-C05A-8E2E13CC0D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50A8690-7E15-7076-B100-1B0A7FA27FA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EE2A554-F3FA-69F6-6886-0004304D04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A0CD62-EA7A-3449-9538-B12C3AD6BBA4}" type="datetimeFigureOut">
              <a:rPr lang="en-US" smtClean="0"/>
              <a:t>6/2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54FF2D6-EF3B-CBC8-A5E2-E9A15F171F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28AEA80-5AF4-DBEE-52A6-7091C29EB3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F17836-3677-1E47-98B4-AD2054ABDD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12768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1223307-5BAC-402E-72A7-3956F712FFF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65EDAD9-66FC-A5A3-A260-12A7527BA37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6C1681-7059-C34B-0146-6E126D4A80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A0CD62-EA7A-3449-9538-B12C3AD6BBA4}" type="datetimeFigureOut">
              <a:rPr lang="en-US" smtClean="0"/>
              <a:t>6/2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7F95FA2-62D0-0649-4FD3-3069A133E6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3E8ABE5-4E20-F770-5703-9D1D8F73C9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F17836-3677-1E47-98B4-AD2054ABDD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71657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7836B0-9572-53A0-96E8-CD19DC0D53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93CCD2F-29EC-5C0C-58D9-561E7BEDCE4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822FCB-0815-E17D-BEA9-D76C4D9D57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A0CD62-EA7A-3449-9538-B12C3AD6BBA4}" type="datetimeFigureOut">
              <a:rPr lang="en-US" smtClean="0"/>
              <a:t>6/2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0515909-6A1A-7C42-9528-5A1059721D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704144B-9056-6486-0F10-0080CD23D2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F17836-3677-1E47-98B4-AD2054ABDD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86580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1CC328-2C11-43E2-B53A-A7B763618A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6A1CD8C-F7C5-AC26-5032-251CBCB497A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D523D15-5405-8EE4-9740-77FA542404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A0CD62-EA7A-3449-9538-B12C3AD6BBA4}" type="datetimeFigureOut">
              <a:rPr lang="en-US" smtClean="0"/>
              <a:t>6/2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8225251-00DE-EAFA-2A09-DBC6049955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6D6CDE1-E964-1E86-A35B-8B85A251F8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F17836-3677-1E47-98B4-AD2054ABDD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22593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C6F495-E1F0-1C3B-9979-2327596C9A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D740AD1-4C19-11DE-CC34-6C8064375B3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3014CD3-B9A0-0CA3-898E-4B584EA993A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3F297CE-1A72-6178-18A5-0159C3CC48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A0CD62-EA7A-3449-9538-B12C3AD6BBA4}" type="datetimeFigureOut">
              <a:rPr lang="en-US" smtClean="0"/>
              <a:t>6/26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1924ECC-5A5C-A003-67AD-CE36E0FA88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886775C-EC8E-7F4C-B7A3-13D02E7628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F17836-3677-1E47-98B4-AD2054ABDD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78659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B9166C-8F41-03B2-E6A4-89A8340702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D518C16-5D10-03D9-8928-71F45AF1EBE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A50ABA4-CC9E-5EE4-E370-F847E2EFFAE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903D48E-5DD0-8334-5838-8B75A493ABA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54B6636-7A8F-00E0-5DD2-09BA6C5C2A8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13EE827-C8D4-BE02-57C7-5D2C4C6C57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A0CD62-EA7A-3449-9538-B12C3AD6BBA4}" type="datetimeFigureOut">
              <a:rPr lang="en-US" smtClean="0"/>
              <a:t>6/26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E4A0F95-EBA1-7A38-5DF7-595B1F5FE4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9FF2476-56F7-C894-4951-A1958394DB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F17836-3677-1E47-98B4-AD2054ABDD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5702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BD5780-8611-7D86-2A3C-44B5C42499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C0A2BBD-E819-9B5D-18BB-208FB99115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A0CD62-EA7A-3449-9538-B12C3AD6BBA4}" type="datetimeFigureOut">
              <a:rPr lang="en-US" smtClean="0"/>
              <a:t>6/26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9CC8980-5D59-8FAB-1098-CB7BF800F2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185733B-56E4-41EC-A415-54481AD7A0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F17836-3677-1E47-98B4-AD2054ABDD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00626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FD9CF28-3AD1-5A4F-E523-BA1C38B511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A0CD62-EA7A-3449-9538-B12C3AD6BBA4}" type="datetimeFigureOut">
              <a:rPr lang="en-US" smtClean="0"/>
              <a:t>6/26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83FB0EC-21E6-EC61-930D-E3230431E2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3D98DE1-3163-7A4C-D0FD-0216013259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F17836-3677-1E47-98B4-AD2054ABDD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93829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0E8AEA-B980-B44D-C0F2-AEC6562059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A1EDE64-5776-ADCC-700F-0BE547B40ED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49421C3-938B-559B-BE39-34FC99BE4A6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17C34F7-3757-A733-C686-6D33DBF15C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A0CD62-EA7A-3449-9538-B12C3AD6BBA4}" type="datetimeFigureOut">
              <a:rPr lang="en-US" smtClean="0"/>
              <a:t>6/26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FC42A19-91AB-8C01-83CC-D4905C1433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E7D7657-98EB-B786-C9C5-06F1C12BEE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F17836-3677-1E47-98B4-AD2054ABDD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16199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DFFEB7-618A-2714-6036-FD624BE536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0548CDF-0A07-5F33-1C26-682AABA13B0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899ACD3-67DB-B8F2-320C-5297D447D4C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AC43736-8FC2-793D-328F-08B58D3BBC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A0CD62-EA7A-3449-9538-B12C3AD6BBA4}" type="datetimeFigureOut">
              <a:rPr lang="en-US" smtClean="0"/>
              <a:t>6/26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EB92F64-6DD2-5037-9E46-E64EDF2CCE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3C0CDEB-37C4-D7D6-A33C-BDA01DC72F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F17836-3677-1E47-98B4-AD2054ABDD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96052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8B9B0CF-D7B6-3071-7E2A-AFD5568DB1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2E54EB5-49B0-5A50-6A1F-46657D7A0CA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CA65163-79F0-E09E-3527-6BFCC812304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A0CD62-EA7A-3449-9538-B12C3AD6BBA4}" type="datetimeFigureOut">
              <a:rPr lang="en-US" smtClean="0"/>
              <a:t>6/2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A2FD9D4-CB3D-B8EA-2E7B-688F5F14932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A35FE7-C61C-5E4B-B05E-55EF6BF7E3E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F17836-3677-1E47-98B4-AD2054ABDD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9664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B5DEA4E1-2848-42B5-4EE6-0717C852144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03857" y="405709"/>
            <a:ext cx="3783343" cy="2423216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CC71BB74-54BC-7055-9702-0D2A1A1C114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103857" y="3921326"/>
            <a:ext cx="3926217" cy="28702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BA96E0E0-A812-4A8D-7364-10F92C4C1052}"/>
              </a:ext>
            </a:extLst>
          </p:cNvPr>
          <p:cNvSpPr txBox="1"/>
          <p:nvPr/>
        </p:nvSpPr>
        <p:spPr>
          <a:xfrm>
            <a:off x="7737038" y="36377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/>
              <a:t>kDa</a:t>
            </a:r>
            <a:endParaRPr lang="en-US" sz="1200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C0097FA-287D-72C6-F6DF-8FB0565506AF}"/>
              </a:ext>
            </a:extLst>
          </p:cNvPr>
          <p:cNvSpPr txBox="1"/>
          <p:nvPr/>
        </p:nvSpPr>
        <p:spPr>
          <a:xfrm>
            <a:off x="7777915" y="452421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5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A88C862-DCEB-B17D-3F40-74E96FABF1A9}"/>
              </a:ext>
            </a:extLst>
          </p:cNvPr>
          <p:cNvSpPr txBox="1"/>
          <p:nvPr/>
        </p:nvSpPr>
        <p:spPr>
          <a:xfrm>
            <a:off x="7777915" y="762141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0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E73EBE2-E2D5-DAE3-068D-A20480B904B6}"/>
              </a:ext>
            </a:extLst>
          </p:cNvPr>
          <p:cNvSpPr txBox="1"/>
          <p:nvPr/>
        </p:nvSpPr>
        <p:spPr>
          <a:xfrm>
            <a:off x="7777915" y="982424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5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91D57C7-E13B-97A2-E92E-623B6D7CD5D8}"/>
              </a:ext>
            </a:extLst>
          </p:cNvPr>
          <p:cNvSpPr txBox="1"/>
          <p:nvPr/>
        </p:nvSpPr>
        <p:spPr>
          <a:xfrm>
            <a:off x="7777915" y="1185449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0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30340286-70E4-E75D-B653-E610BA909051}"/>
              </a:ext>
            </a:extLst>
          </p:cNvPr>
          <p:cNvSpPr txBox="1"/>
          <p:nvPr/>
        </p:nvSpPr>
        <p:spPr>
          <a:xfrm>
            <a:off x="7818792" y="1812978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5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6587AE5-0A75-ED5E-3E7B-12FE977438F8}"/>
              </a:ext>
            </a:extLst>
          </p:cNvPr>
          <p:cNvSpPr txBox="1"/>
          <p:nvPr/>
        </p:nvSpPr>
        <p:spPr>
          <a:xfrm>
            <a:off x="7818792" y="2122698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0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74E425F-3C9B-875E-9EA1-44000C316044}"/>
              </a:ext>
            </a:extLst>
          </p:cNvPr>
          <p:cNvSpPr txBox="1"/>
          <p:nvPr/>
        </p:nvSpPr>
        <p:spPr>
          <a:xfrm>
            <a:off x="7818792" y="2342981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5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76C3186-4D21-6F4A-E4F8-DCAA211994CC}"/>
              </a:ext>
            </a:extLst>
          </p:cNvPr>
          <p:cNvSpPr txBox="1"/>
          <p:nvPr/>
        </p:nvSpPr>
        <p:spPr>
          <a:xfrm>
            <a:off x="7818792" y="2546006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0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50EA01E9-7E52-CBFB-6845-5618E4312837}"/>
              </a:ext>
            </a:extLst>
          </p:cNvPr>
          <p:cNvSpPr txBox="1"/>
          <p:nvPr/>
        </p:nvSpPr>
        <p:spPr>
          <a:xfrm>
            <a:off x="7818792" y="4140568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5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825F9979-8364-2993-65DD-C0BBD6F4214B}"/>
              </a:ext>
            </a:extLst>
          </p:cNvPr>
          <p:cNvSpPr txBox="1"/>
          <p:nvPr/>
        </p:nvSpPr>
        <p:spPr>
          <a:xfrm>
            <a:off x="7818792" y="4450288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0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477AEEE2-B1A3-504F-24EB-4A1536225D8F}"/>
              </a:ext>
            </a:extLst>
          </p:cNvPr>
          <p:cNvSpPr txBox="1"/>
          <p:nvPr/>
        </p:nvSpPr>
        <p:spPr>
          <a:xfrm>
            <a:off x="7818792" y="4670571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5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51EA6F9B-F593-0498-7DF1-A8D62FB39BCD}"/>
              </a:ext>
            </a:extLst>
          </p:cNvPr>
          <p:cNvSpPr txBox="1"/>
          <p:nvPr/>
        </p:nvSpPr>
        <p:spPr>
          <a:xfrm>
            <a:off x="7818792" y="4873596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0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6DF25574-2AA5-43B8-6557-A6F59C246C16}"/>
              </a:ext>
            </a:extLst>
          </p:cNvPr>
          <p:cNvSpPr txBox="1"/>
          <p:nvPr/>
        </p:nvSpPr>
        <p:spPr>
          <a:xfrm>
            <a:off x="7818792" y="5626639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5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5E5E64A7-2510-272A-6ADF-EB0590DA60B2}"/>
              </a:ext>
            </a:extLst>
          </p:cNvPr>
          <p:cNvSpPr txBox="1"/>
          <p:nvPr/>
        </p:nvSpPr>
        <p:spPr>
          <a:xfrm>
            <a:off x="7818792" y="5936359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0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AF8CD0DD-3B1B-761A-7AAA-DDF71F2E8898}"/>
              </a:ext>
            </a:extLst>
          </p:cNvPr>
          <p:cNvSpPr txBox="1"/>
          <p:nvPr/>
        </p:nvSpPr>
        <p:spPr>
          <a:xfrm>
            <a:off x="7818792" y="6156642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5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29506FE8-A5C8-45F8-2647-16A7F53D1DE3}"/>
              </a:ext>
            </a:extLst>
          </p:cNvPr>
          <p:cNvSpPr txBox="1"/>
          <p:nvPr/>
        </p:nvSpPr>
        <p:spPr>
          <a:xfrm>
            <a:off x="7818792" y="6359667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0</a:t>
            </a:r>
          </a:p>
        </p:txBody>
      </p:sp>
      <p:pic>
        <p:nvPicPr>
          <p:cNvPr id="26" name="Picture 25">
            <a:extLst>
              <a:ext uri="{FF2B5EF4-FFF2-40B4-BE49-F238E27FC236}">
                <a16:creationId xmlns:a16="http://schemas.microsoft.com/office/drawing/2014/main" id="{664A84D4-9BB8-466D-A62B-D6FDE7EC68F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8618" t="19832" r="54322" b="59964"/>
          <a:stretch/>
        </p:blipFill>
        <p:spPr>
          <a:xfrm>
            <a:off x="2043485" y="882595"/>
            <a:ext cx="1455089" cy="579853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D384FF77-23CB-A035-D922-B357A4DC34A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8351" t="74348" r="54588" b="10415"/>
          <a:stretch/>
        </p:blipFill>
        <p:spPr>
          <a:xfrm>
            <a:off x="2069139" y="2684504"/>
            <a:ext cx="1455089" cy="437323"/>
          </a:xfrm>
          <a:prstGeom prst="rect">
            <a:avLst/>
          </a:prstGeom>
        </p:spPr>
      </p:pic>
      <p:sp>
        <p:nvSpPr>
          <p:cNvPr id="28" name="TextBox 27">
            <a:extLst>
              <a:ext uri="{FF2B5EF4-FFF2-40B4-BE49-F238E27FC236}">
                <a16:creationId xmlns:a16="http://schemas.microsoft.com/office/drawing/2014/main" id="{F9D6B8C9-CE6C-8CA1-9963-E6C22D2D68F1}"/>
              </a:ext>
            </a:extLst>
          </p:cNvPr>
          <p:cNvSpPr txBox="1"/>
          <p:nvPr/>
        </p:nvSpPr>
        <p:spPr>
          <a:xfrm>
            <a:off x="159684" y="954509"/>
            <a:ext cx="146456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ull-downs with</a:t>
            </a:r>
          </a:p>
          <a:p>
            <a:r>
              <a:rPr lang="en-US" sz="1200" dirty="0"/>
              <a:t>PG from plain media</a:t>
            </a:r>
          </a:p>
        </p:txBody>
      </p:sp>
      <p:pic>
        <p:nvPicPr>
          <p:cNvPr id="30" name="Picture 29">
            <a:extLst>
              <a:ext uri="{FF2B5EF4-FFF2-40B4-BE49-F238E27FC236}">
                <a16:creationId xmlns:a16="http://schemas.microsoft.com/office/drawing/2014/main" id="{4A45054A-B4C3-BC35-A306-EBCD8FED00B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3344" t="19832" r="9971" b="59964"/>
          <a:stretch/>
        </p:blipFill>
        <p:spPr>
          <a:xfrm>
            <a:off x="4234876" y="882593"/>
            <a:ext cx="1440359" cy="579853"/>
          </a:xfrm>
          <a:prstGeom prst="rect">
            <a:avLst/>
          </a:prstGeom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4848A2F3-0D5F-8CC5-97D5-69A7D1E873DF}"/>
              </a:ext>
            </a:extLst>
          </p:cNvPr>
          <p:cNvSpPr txBox="1"/>
          <p:nvPr/>
        </p:nvSpPr>
        <p:spPr>
          <a:xfrm>
            <a:off x="2314012" y="623456"/>
            <a:ext cx="8378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 </a:t>
            </a:r>
            <a:r>
              <a:rPr lang="en-US" sz="1200" dirty="0" err="1"/>
              <a:t>uM</a:t>
            </a:r>
            <a:r>
              <a:rPr lang="en-US" sz="1200" dirty="0"/>
              <a:t> Tae1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A57CC9C2-B408-8480-B738-E5A64F6FE6DF}"/>
              </a:ext>
            </a:extLst>
          </p:cNvPr>
          <p:cNvSpPr txBox="1"/>
          <p:nvPr/>
        </p:nvSpPr>
        <p:spPr>
          <a:xfrm>
            <a:off x="4552509" y="623456"/>
            <a:ext cx="9548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0.1 </a:t>
            </a:r>
            <a:r>
              <a:rPr lang="en-US" sz="1200" dirty="0" err="1"/>
              <a:t>uM</a:t>
            </a:r>
            <a:r>
              <a:rPr lang="en-US" sz="1200" dirty="0"/>
              <a:t> Tae1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246B95C5-8398-04F8-80A9-8CB55EF341A8}"/>
              </a:ext>
            </a:extLst>
          </p:cNvPr>
          <p:cNvSpPr txBox="1"/>
          <p:nvPr/>
        </p:nvSpPr>
        <p:spPr>
          <a:xfrm>
            <a:off x="2091373" y="1436553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ABA5E3F4-7EBF-7BCF-D7FB-32669529873A}"/>
              </a:ext>
            </a:extLst>
          </p:cNvPr>
          <p:cNvSpPr txBox="1"/>
          <p:nvPr/>
        </p:nvSpPr>
        <p:spPr>
          <a:xfrm>
            <a:off x="2443622" y="1436553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2DC55120-6D23-151C-6C5B-E3310850651B}"/>
              </a:ext>
            </a:extLst>
          </p:cNvPr>
          <p:cNvSpPr txBox="1"/>
          <p:nvPr/>
        </p:nvSpPr>
        <p:spPr>
          <a:xfrm>
            <a:off x="2796684" y="1436553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3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80F96B67-DEAE-FA91-C137-9F6569E41733}"/>
              </a:ext>
            </a:extLst>
          </p:cNvPr>
          <p:cNvSpPr txBox="1"/>
          <p:nvPr/>
        </p:nvSpPr>
        <p:spPr>
          <a:xfrm>
            <a:off x="3171443" y="1436553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4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7A952DEA-2066-5FCA-4C18-07DEC7B93642}"/>
              </a:ext>
            </a:extLst>
          </p:cNvPr>
          <p:cNvSpPr txBox="1"/>
          <p:nvPr/>
        </p:nvSpPr>
        <p:spPr>
          <a:xfrm>
            <a:off x="4299303" y="1436553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85E4CDCD-4CF0-65C2-B868-005F4C2B2462}"/>
              </a:ext>
            </a:extLst>
          </p:cNvPr>
          <p:cNvSpPr txBox="1"/>
          <p:nvPr/>
        </p:nvSpPr>
        <p:spPr>
          <a:xfrm>
            <a:off x="4651552" y="1436553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C80B5117-2E24-B4E7-AA49-56D0B1ED5987}"/>
              </a:ext>
            </a:extLst>
          </p:cNvPr>
          <p:cNvSpPr txBox="1"/>
          <p:nvPr/>
        </p:nvSpPr>
        <p:spPr>
          <a:xfrm>
            <a:off x="5004614" y="1436553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3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4B521593-FBEF-FB0C-414C-1E48A6BAAB86}"/>
              </a:ext>
            </a:extLst>
          </p:cNvPr>
          <p:cNvSpPr txBox="1"/>
          <p:nvPr/>
        </p:nvSpPr>
        <p:spPr>
          <a:xfrm>
            <a:off x="5379373" y="1436553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4</a:t>
            </a:r>
          </a:p>
        </p:txBody>
      </p:sp>
      <p:pic>
        <p:nvPicPr>
          <p:cNvPr id="41" name="Picture 40">
            <a:extLst>
              <a:ext uri="{FF2B5EF4-FFF2-40B4-BE49-F238E27FC236}">
                <a16:creationId xmlns:a16="http://schemas.microsoft.com/office/drawing/2014/main" id="{69D09230-4440-8938-2AED-5A2BFAE7C57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5528" t="74348" r="16416" b="10415"/>
          <a:stretch/>
        </p:blipFill>
        <p:spPr>
          <a:xfrm>
            <a:off x="4201192" y="2684505"/>
            <a:ext cx="1494174" cy="437323"/>
          </a:xfrm>
          <a:prstGeom prst="rect">
            <a:avLst/>
          </a:prstGeom>
        </p:spPr>
      </p:pic>
      <p:sp>
        <p:nvSpPr>
          <p:cNvPr id="42" name="TextBox 41">
            <a:extLst>
              <a:ext uri="{FF2B5EF4-FFF2-40B4-BE49-F238E27FC236}">
                <a16:creationId xmlns:a16="http://schemas.microsoft.com/office/drawing/2014/main" id="{67C8B394-8DBD-88B8-81F9-CA3C3F47E418}"/>
              </a:ext>
            </a:extLst>
          </p:cNvPr>
          <p:cNvSpPr txBox="1"/>
          <p:nvPr/>
        </p:nvSpPr>
        <p:spPr>
          <a:xfrm>
            <a:off x="161668" y="2684504"/>
            <a:ext cx="15599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ull-downs with</a:t>
            </a:r>
          </a:p>
          <a:p>
            <a:r>
              <a:rPr lang="en-US" sz="1200" dirty="0"/>
              <a:t>PG from D-Met media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8BE329D4-383C-0C44-CBDF-F8AD414C920F}"/>
              </a:ext>
            </a:extLst>
          </p:cNvPr>
          <p:cNvSpPr txBox="1"/>
          <p:nvPr/>
        </p:nvSpPr>
        <p:spPr>
          <a:xfrm>
            <a:off x="2301158" y="2400464"/>
            <a:ext cx="8378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 </a:t>
            </a:r>
            <a:r>
              <a:rPr lang="en-US" sz="1200" dirty="0" err="1"/>
              <a:t>uM</a:t>
            </a:r>
            <a:r>
              <a:rPr lang="en-US" sz="1200" dirty="0"/>
              <a:t> Tae1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B97DC9AE-6218-902A-F9B3-606EF99EF0F5}"/>
              </a:ext>
            </a:extLst>
          </p:cNvPr>
          <p:cNvSpPr txBox="1"/>
          <p:nvPr/>
        </p:nvSpPr>
        <p:spPr>
          <a:xfrm>
            <a:off x="4539655" y="2400463"/>
            <a:ext cx="9548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0.1 </a:t>
            </a:r>
            <a:r>
              <a:rPr lang="en-US" sz="1200" dirty="0" err="1"/>
              <a:t>uM</a:t>
            </a:r>
            <a:r>
              <a:rPr lang="en-US" sz="1200" dirty="0"/>
              <a:t> Tae1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52B2E2B0-D517-3C7F-A340-63810199554D}"/>
              </a:ext>
            </a:extLst>
          </p:cNvPr>
          <p:cNvSpPr txBox="1"/>
          <p:nvPr/>
        </p:nvSpPr>
        <p:spPr>
          <a:xfrm>
            <a:off x="2111649" y="3087667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3BB8F843-CD1C-EC53-BD04-87AA25A0EDBD}"/>
              </a:ext>
            </a:extLst>
          </p:cNvPr>
          <p:cNvSpPr txBox="1"/>
          <p:nvPr/>
        </p:nvSpPr>
        <p:spPr>
          <a:xfrm>
            <a:off x="2463898" y="3087667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83EF7240-F889-A6CE-3828-E11CE3C6627E}"/>
              </a:ext>
            </a:extLst>
          </p:cNvPr>
          <p:cNvSpPr txBox="1"/>
          <p:nvPr/>
        </p:nvSpPr>
        <p:spPr>
          <a:xfrm>
            <a:off x="2816960" y="3087667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3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C82B9CFC-0E4E-A4B4-4ABB-557BBFD8D85A}"/>
              </a:ext>
            </a:extLst>
          </p:cNvPr>
          <p:cNvSpPr txBox="1"/>
          <p:nvPr/>
        </p:nvSpPr>
        <p:spPr>
          <a:xfrm>
            <a:off x="3191719" y="3087667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4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7712D625-2C6B-7610-599C-5E9B05C54989}"/>
              </a:ext>
            </a:extLst>
          </p:cNvPr>
          <p:cNvSpPr txBox="1"/>
          <p:nvPr/>
        </p:nvSpPr>
        <p:spPr>
          <a:xfrm>
            <a:off x="4286449" y="3087667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36C436F2-2613-31AD-3F2E-13FFB1FDBCA5}"/>
              </a:ext>
            </a:extLst>
          </p:cNvPr>
          <p:cNvSpPr txBox="1"/>
          <p:nvPr/>
        </p:nvSpPr>
        <p:spPr>
          <a:xfrm>
            <a:off x="4638698" y="3087667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D086CCBB-D352-D32B-3225-6D116B5CF6C2}"/>
              </a:ext>
            </a:extLst>
          </p:cNvPr>
          <p:cNvSpPr txBox="1"/>
          <p:nvPr/>
        </p:nvSpPr>
        <p:spPr>
          <a:xfrm>
            <a:off x="4991760" y="3087667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3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724C524D-6EA9-E5BA-DF6C-C4840DF2D61F}"/>
              </a:ext>
            </a:extLst>
          </p:cNvPr>
          <p:cNvSpPr txBox="1"/>
          <p:nvPr/>
        </p:nvSpPr>
        <p:spPr>
          <a:xfrm>
            <a:off x="5366519" y="3087667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4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F3080008-A1E7-17CB-B815-E83EA85B0FF7}"/>
              </a:ext>
            </a:extLst>
          </p:cNvPr>
          <p:cNvSpPr txBox="1"/>
          <p:nvPr/>
        </p:nvSpPr>
        <p:spPr>
          <a:xfrm>
            <a:off x="7772893" y="3683543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/>
              <a:t>kDa</a:t>
            </a:r>
            <a:endParaRPr lang="en-US" sz="1200" dirty="0"/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858042B5-3ECD-AEED-440E-65EB88A3B826}"/>
              </a:ext>
            </a:extLst>
          </p:cNvPr>
          <p:cNvSpPr txBox="1"/>
          <p:nvPr/>
        </p:nvSpPr>
        <p:spPr>
          <a:xfrm>
            <a:off x="9810333" y="61562"/>
            <a:ext cx="9331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MW marker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3102F8BC-0743-A266-4931-870E72FB388C}"/>
              </a:ext>
            </a:extLst>
          </p:cNvPr>
          <p:cNvSpPr txBox="1"/>
          <p:nvPr/>
        </p:nvSpPr>
        <p:spPr>
          <a:xfrm>
            <a:off x="9810332" y="3644327"/>
            <a:ext cx="8518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Blot image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B5BC3796-CA47-CBEC-9577-63176AC50D29}"/>
              </a:ext>
            </a:extLst>
          </p:cNvPr>
          <p:cNvSpPr txBox="1"/>
          <p:nvPr/>
        </p:nvSpPr>
        <p:spPr>
          <a:xfrm>
            <a:off x="2668672" y="4244342"/>
            <a:ext cx="2518831" cy="15696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Helvetica" pitchFamily="2" charset="0"/>
              </a:rPr>
              <a:t>Lanes:</a:t>
            </a:r>
          </a:p>
          <a:p>
            <a:r>
              <a:rPr lang="en-US" sz="1200" dirty="0">
                <a:latin typeface="Helvetica" pitchFamily="2" charset="0"/>
              </a:rPr>
              <a:t>1-Tae1 WT</a:t>
            </a:r>
          </a:p>
          <a:p>
            <a:r>
              <a:rPr lang="en-US" sz="1200" dirty="0">
                <a:latin typeface="Helvetica" pitchFamily="2" charset="0"/>
              </a:rPr>
              <a:t>2-Tae1 C30A</a:t>
            </a:r>
          </a:p>
          <a:p>
            <a:r>
              <a:rPr lang="en-US" sz="1200" dirty="0">
                <a:latin typeface="Helvetica" pitchFamily="2" charset="0"/>
              </a:rPr>
              <a:t>3-Tae1 G48S</a:t>
            </a:r>
          </a:p>
          <a:p>
            <a:r>
              <a:rPr lang="en-US" sz="1200" dirty="0">
                <a:latin typeface="Helvetica" pitchFamily="2" charset="0"/>
              </a:rPr>
              <a:t>4-Tae1 S144A</a:t>
            </a:r>
          </a:p>
          <a:p>
            <a:endParaRPr lang="en-US" sz="1200" dirty="0">
              <a:latin typeface="Helvetica" pitchFamily="2" charset="0"/>
            </a:endParaRPr>
          </a:p>
          <a:p>
            <a:r>
              <a:rPr lang="en-US" sz="1200" dirty="0">
                <a:latin typeface="Helvetica" pitchFamily="2" charset="0"/>
              </a:rPr>
              <a:t>Both Tae1 G48S and Tae1 S144A </a:t>
            </a:r>
          </a:p>
          <a:p>
            <a:r>
              <a:rPr lang="en-US" sz="1200" dirty="0">
                <a:latin typeface="Helvetica" pitchFamily="2" charset="0"/>
              </a:rPr>
              <a:t>are LOF variants</a:t>
            </a:r>
          </a:p>
        </p:txBody>
      </p:sp>
    </p:spTree>
    <p:extLst>
      <p:ext uri="{BB962C8B-B14F-4D97-AF65-F5344CB8AC3E}">
        <p14:creationId xmlns:p14="http://schemas.microsoft.com/office/powerpoint/2010/main" val="9685666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585D6F2C-4BCA-3DCC-0506-21BD760B422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8618" t="19832" r="54322" b="59964"/>
          <a:stretch/>
        </p:blipFill>
        <p:spPr>
          <a:xfrm>
            <a:off x="2293856" y="882595"/>
            <a:ext cx="1455089" cy="579853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0044775A-92AB-2B45-C345-C9F272869E3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8351" t="74348" r="54588" b="10415"/>
          <a:stretch/>
        </p:blipFill>
        <p:spPr>
          <a:xfrm>
            <a:off x="2319510" y="2684504"/>
            <a:ext cx="1455089" cy="437323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133BFAE0-82B6-B822-FB8D-9EB5726C6CE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3344" t="19832" r="9971" b="59964"/>
          <a:stretch/>
        </p:blipFill>
        <p:spPr>
          <a:xfrm>
            <a:off x="4485247" y="882593"/>
            <a:ext cx="1440359" cy="579853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05F0B9E1-2E90-E67A-9634-7978DBDD2531}"/>
              </a:ext>
            </a:extLst>
          </p:cNvPr>
          <p:cNvSpPr txBox="1"/>
          <p:nvPr/>
        </p:nvSpPr>
        <p:spPr>
          <a:xfrm>
            <a:off x="2564383" y="623456"/>
            <a:ext cx="9022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Helvetica" pitchFamily="2" charset="0"/>
              </a:rPr>
              <a:t>1 µM Tae1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4499A5E-0912-FEE0-E7BB-668BA8CAC155}"/>
              </a:ext>
            </a:extLst>
          </p:cNvPr>
          <p:cNvSpPr txBox="1"/>
          <p:nvPr/>
        </p:nvSpPr>
        <p:spPr>
          <a:xfrm>
            <a:off x="4802880" y="623456"/>
            <a:ext cx="10305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Helvetica" pitchFamily="2" charset="0"/>
              </a:rPr>
              <a:t>0.1 µM Tae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276E116-560E-9647-FBA3-A46105860DA4}"/>
              </a:ext>
            </a:extLst>
          </p:cNvPr>
          <p:cNvSpPr txBox="1"/>
          <p:nvPr/>
        </p:nvSpPr>
        <p:spPr>
          <a:xfrm rot="16200000">
            <a:off x="2254656" y="1492942"/>
            <a:ext cx="4251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Helvetica" pitchFamily="2" charset="0"/>
              </a:rPr>
              <a:t>WT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909C724-02BC-281C-B710-11EB238A3F64}"/>
              </a:ext>
            </a:extLst>
          </p:cNvPr>
          <p:cNvSpPr txBox="1"/>
          <p:nvPr/>
        </p:nvSpPr>
        <p:spPr>
          <a:xfrm rot="16200000">
            <a:off x="2543662" y="1564276"/>
            <a:ext cx="5677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Helvetica" pitchFamily="2" charset="0"/>
              </a:rPr>
              <a:t>C30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D271FBA-3F64-7D21-E74E-E0110B153D91}"/>
              </a:ext>
            </a:extLst>
          </p:cNvPr>
          <p:cNvSpPr txBox="1"/>
          <p:nvPr/>
        </p:nvSpPr>
        <p:spPr>
          <a:xfrm rot="16200000">
            <a:off x="2899193" y="1569085"/>
            <a:ext cx="5774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Helvetica" pitchFamily="2" charset="0"/>
              </a:rPr>
              <a:t>G48S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1DCE88B-0617-83A9-17B1-A9AF04878BC9}"/>
              </a:ext>
            </a:extLst>
          </p:cNvPr>
          <p:cNvSpPr txBox="1"/>
          <p:nvPr/>
        </p:nvSpPr>
        <p:spPr>
          <a:xfrm rot="16200000">
            <a:off x="3225871" y="1602748"/>
            <a:ext cx="6447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Helvetica" pitchFamily="2" charset="0"/>
              </a:rPr>
              <a:t>S144A</a:t>
            </a: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F3BDAA8A-1CA0-7166-E49C-587B84D0A61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5528" t="74348" r="16416" b="10415"/>
          <a:stretch/>
        </p:blipFill>
        <p:spPr>
          <a:xfrm>
            <a:off x="4451563" y="2684505"/>
            <a:ext cx="1494174" cy="437323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589E919B-8DD1-68F3-8A07-4E0599A81F19}"/>
              </a:ext>
            </a:extLst>
          </p:cNvPr>
          <p:cNvSpPr txBox="1"/>
          <p:nvPr/>
        </p:nvSpPr>
        <p:spPr>
          <a:xfrm>
            <a:off x="2551529" y="2400464"/>
            <a:ext cx="9022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Helvetica" pitchFamily="2" charset="0"/>
              </a:rPr>
              <a:t>1 µM Tae1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BA7743C1-EEDB-D7CE-8E97-DD017697EB5B}"/>
              </a:ext>
            </a:extLst>
          </p:cNvPr>
          <p:cNvSpPr txBox="1"/>
          <p:nvPr/>
        </p:nvSpPr>
        <p:spPr>
          <a:xfrm>
            <a:off x="4790026" y="2400463"/>
            <a:ext cx="10305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Helvetica" pitchFamily="2" charset="0"/>
              </a:rPr>
              <a:t>0.1 µM Tae1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F436CF6F-C4AF-A95C-1A47-B33EFB6C425D}"/>
              </a:ext>
            </a:extLst>
          </p:cNvPr>
          <p:cNvSpPr txBox="1"/>
          <p:nvPr/>
        </p:nvSpPr>
        <p:spPr>
          <a:xfrm>
            <a:off x="699036" y="990475"/>
            <a:ext cx="149592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Helvetica" pitchFamily="2" charset="0"/>
              </a:rPr>
              <a:t>Bait for pull-down:</a:t>
            </a:r>
          </a:p>
          <a:p>
            <a:pPr algn="ctr"/>
            <a:r>
              <a:rPr lang="en-US" sz="1200" dirty="0">
                <a:latin typeface="Helvetica" pitchFamily="2" charset="0"/>
              </a:rPr>
              <a:t>Plain media sacculi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6E296900-D751-5CF5-4AA8-6F221675E73E}"/>
              </a:ext>
            </a:extLst>
          </p:cNvPr>
          <p:cNvSpPr txBox="1"/>
          <p:nvPr/>
        </p:nvSpPr>
        <p:spPr>
          <a:xfrm>
            <a:off x="699036" y="2692820"/>
            <a:ext cx="157447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Helvetica" pitchFamily="2" charset="0"/>
              </a:rPr>
              <a:t>Bait for pull-down:</a:t>
            </a:r>
          </a:p>
          <a:p>
            <a:pPr algn="ctr"/>
            <a:r>
              <a:rPr lang="en-US" sz="1200" dirty="0">
                <a:latin typeface="Helvetica" pitchFamily="2" charset="0"/>
              </a:rPr>
              <a:t>D-Met media sacculi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DBC044DE-8D1B-87E2-CDC8-E064142051F9}"/>
              </a:ext>
            </a:extLst>
          </p:cNvPr>
          <p:cNvSpPr txBox="1"/>
          <p:nvPr/>
        </p:nvSpPr>
        <p:spPr>
          <a:xfrm rot="16200000">
            <a:off x="4469013" y="1526199"/>
            <a:ext cx="4251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Helvetica" pitchFamily="2" charset="0"/>
              </a:rPr>
              <a:t>WT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BDAB898F-B983-3B01-5816-F244B212D67C}"/>
              </a:ext>
            </a:extLst>
          </p:cNvPr>
          <p:cNvSpPr txBox="1"/>
          <p:nvPr/>
        </p:nvSpPr>
        <p:spPr>
          <a:xfrm rot="16200000">
            <a:off x="4758019" y="1597533"/>
            <a:ext cx="5677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Helvetica" pitchFamily="2" charset="0"/>
              </a:rPr>
              <a:t>C30A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E07F4C79-19F3-643E-2CD5-458A54DB0549}"/>
              </a:ext>
            </a:extLst>
          </p:cNvPr>
          <p:cNvSpPr txBox="1"/>
          <p:nvPr/>
        </p:nvSpPr>
        <p:spPr>
          <a:xfrm rot="16200000">
            <a:off x="5113550" y="1602342"/>
            <a:ext cx="5774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Helvetica" pitchFamily="2" charset="0"/>
              </a:rPr>
              <a:t>G48S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070E3FDB-E6A4-80F5-ED3D-8349A52CB627}"/>
              </a:ext>
            </a:extLst>
          </p:cNvPr>
          <p:cNvSpPr txBox="1"/>
          <p:nvPr/>
        </p:nvSpPr>
        <p:spPr>
          <a:xfrm rot="16200000">
            <a:off x="5440228" y="1636005"/>
            <a:ext cx="6447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Helvetica" pitchFamily="2" charset="0"/>
              </a:rPr>
              <a:t>S144A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AD11D428-BE6C-BADB-1A90-D08AE417A386}"/>
              </a:ext>
            </a:extLst>
          </p:cNvPr>
          <p:cNvSpPr txBox="1"/>
          <p:nvPr/>
        </p:nvSpPr>
        <p:spPr>
          <a:xfrm rot="16200000">
            <a:off x="4450617" y="3164015"/>
            <a:ext cx="4251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Helvetica" pitchFamily="2" charset="0"/>
              </a:rPr>
              <a:t>WT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B8FF1912-EBBD-AFBE-2570-0F58724BD4B5}"/>
              </a:ext>
            </a:extLst>
          </p:cNvPr>
          <p:cNvSpPr txBox="1"/>
          <p:nvPr/>
        </p:nvSpPr>
        <p:spPr>
          <a:xfrm rot="16200000">
            <a:off x="4739623" y="3235349"/>
            <a:ext cx="5677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Helvetica" pitchFamily="2" charset="0"/>
              </a:rPr>
              <a:t>C30A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FAF75AD0-FF06-B0D1-FD0E-4A25807EA7A9}"/>
              </a:ext>
            </a:extLst>
          </p:cNvPr>
          <p:cNvSpPr txBox="1"/>
          <p:nvPr/>
        </p:nvSpPr>
        <p:spPr>
          <a:xfrm rot="16200000">
            <a:off x="5095154" y="3240158"/>
            <a:ext cx="5774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Helvetica" pitchFamily="2" charset="0"/>
              </a:rPr>
              <a:t>G48S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7C1570C8-60DE-CDD2-D822-165270BCB17D}"/>
              </a:ext>
            </a:extLst>
          </p:cNvPr>
          <p:cNvSpPr txBox="1"/>
          <p:nvPr/>
        </p:nvSpPr>
        <p:spPr>
          <a:xfrm rot="16200000">
            <a:off x="5421832" y="3273821"/>
            <a:ext cx="6447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Helvetica" pitchFamily="2" charset="0"/>
              </a:rPr>
              <a:t>S144A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E0B79C90-46D2-844E-5180-14AB09235D50}"/>
              </a:ext>
            </a:extLst>
          </p:cNvPr>
          <p:cNvSpPr txBox="1"/>
          <p:nvPr/>
        </p:nvSpPr>
        <p:spPr>
          <a:xfrm rot="16200000">
            <a:off x="2254656" y="3164015"/>
            <a:ext cx="4251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Helvetica" pitchFamily="2" charset="0"/>
              </a:rPr>
              <a:t>WT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EFF1DD76-1FA1-DF1D-138A-F7AD92B08DB1}"/>
              </a:ext>
            </a:extLst>
          </p:cNvPr>
          <p:cNvSpPr txBox="1"/>
          <p:nvPr/>
        </p:nvSpPr>
        <p:spPr>
          <a:xfrm rot="16200000">
            <a:off x="2543662" y="3235349"/>
            <a:ext cx="5677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Helvetica" pitchFamily="2" charset="0"/>
              </a:rPr>
              <a:t>C30A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1C1647CF-6C54-832D-A7D3-B1937775953C}"/>
              </a:ext>
            </a:extLst>
          </p:cNvPr>
          <p:cNvSpPr txBox="1"/>
          <p:nvPr/>
        </p:nvSpPr>
        <p:spPr>
          <a:xfrm rot="16200000">
            <a:off x="2899193" y="3240158"/>
            <a:ext cx="5774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Helvetica" pitchFamily="2" charset="0"/>
              </a:rPr>
              <a:t>G48S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B60960AC-69A0-A5D5-1DCB-707DB4E9D7FC}"/>
              </a:ext>
            </a:extLst>
          </p:cNvPr>
          <p:cNvSpPr txBox="1"/>
          <p:nvPr/>
        </p:nvSpPr>
        <p:spPr>
          <a:xfrm rot="16200000">
            <a:off x="3225871" y="3273821"/>
            <a:ext cx="6447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Helvetica" pitchFamily="2" charset="0"/>
              </a:rPr>
              <a:t>S144A</a:t>
            </a:r>
          </a:p>
        </p:txBody>
      </p:sp>
    </p:spTree>
    <p:extLst>
      <p:ext uri="{BB962C8B-B14F-4D97-AF65-F5344CB8AC3E}">
        <p14:creationId xmlns:p14="http://schemas.microsoft.com/office/powerpoint/2010/main" val="2237095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6</TotalTime>
  <Words>123</Words>
  <Application>Microsoft Macintosh PowerPoint</Application>
  <PresentationFormat>Widescreen</PresentationFormat>
  <Paragraphs>76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Helvetica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dkov, Atanas</dc:creator>
  <cp:lastModifiedBy>Radkov, Atanas</cp:lastModifiedBy>
  <cp:revision>11</cp:revision>
  <dcterms:created xsi:type="dcterms:W3CDTF">2022-05-01T17:06:43Z</dcterms:created>
  <dcterms:modified xsi:type="dcterms:W3CDTF">2022-06-26T17:45:31Z</dcterms:modified>
</cp:coreProperties>
</file>